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BEC603-E147-4D57-B78B-C67180F6C494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FBA0AD-16D2-4081-8D3A-C1B467E15FFD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5BC4A3-C5BF-4DB2-A47F-30B1E9FE0E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EB67A7-EE34-46A9-9BAF-54D67AEDA4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F9F2C1-2CBF-43EC-ABBF-824A683AEF9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BBE00-A2C7-44FC-95BA-5EBC3417F1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6AA2B-931A-4470-8AA8-59B87FFEDE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240209-515C-4B94-AD9F-5C143F2625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A16A1-99FE-4687-BCA6-9BD15EEBE0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4D6233-E600-45F5-812B-4A0CED6D90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828FD2-6FEC-4C1A-AFAA-AA1791B548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DE8F35-093E-487F-8F60-C2A1768E37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381D8F-341E-4176-8824-7383BE19A5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9C3FC-F983-4808-A87C-93E0F2ACB9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5A535E-CD3F-4A5C-984D-4EA9C20F754E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6.png"/><Relationship Id="rId8" Type="http://schemas.openxmlformats.org/officeDocument/2006/relationships/image" Target="../media/image3.png"/><Relationship Id="rId9" Type="http://schemas.openxmlformats.org/officeDocument/2006/relationships/image" Target="../media/image4.png"/><Relationship Id="rId10" Type="http://schemas.openxmlformats.org/officeDocument/2006/relationships/image" Target="../media/image7.png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2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5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Rectangle 7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10"/>
          <p:cNvSpPr/>
          <p:nvPr/>
        </p:nvSpPr>
        <p:spPr>
          <a:xfrm>
            <a:off x="3132000" y="5013360"/>
            <a:ext cx="2952720" cy="431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3"/>
          <p:cNvSpPr/>
          <p:nvPr/>
        </p:nvSpPr>
        <p:spPr>
          <a:xfrm>
            <a:off x="900000" y="549360"/>
            <a:ext cx="2087640" cy="3585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6"/>
          <p:cNvSpPr/>
          <p:nvPr/>
        </p:nvSpPr>
        <p:spPr>
          <a:xfrm>
            <a:off x="826920" y="189000"/>
            <a:ext cx="81378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1.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 Outline of the MRC UKALL 2003 trial protocol detailing drugs used and timing schedules for the three regimens.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</a:rPr>
              <a:t>Patients were allocated to therapy as detailed in the main text.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15"/>
          <p:cNvSpPr/>
          <p:nvPr/>
        </p:nvSpPr>
        <p:spPr>
          <a:xfrm>
            <a:off x="1619280" y="1844640"/>
            <a:ext cx="6265800" cy="57636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Straight Connector 17"/>
          <p:cNvSpPr/>
          <p:nvPr/>
        </p:nvSpPr>
        <p:spPr>
          <a:xfrm>
            <a:off x="3276720" y="184464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Straight Connector 18"/>
          <p:cNvSpPr/>
          <p:nvPr/>
        </p:nvSpPr>
        <p:spPr>
          <a:xfrm>
            <a:off x="6300720" y="1844640"/>
            <a:ext cx="0" cy="576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0"/>
          <p:cNvSpPr/>
          <p:nvPr/>
        </p:nvSpPr>
        <p:spPr>
          <a:xfrm>
            <a:off x="644040" y="1341360"/>
            <a:ext cx="7101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Regimen             Induction                           Consolidation                            Maintenance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21"/>
          <p:cNvSpPr/>
          <p:nvPr/>
        </p:nvSpPr>
        <p:spPr>
          <a:xfrm>
            <a:off x="900000" y="193032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23"/>
          <p:cNvSpPr/>
          <p:nvPr/>
        </p:nvSpPr>
        <p:spPr>
          <a:xfrm>
            <a:off x="900000" y="340200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24"/>
          <p:cNvSpPr/>
          <p:nvPr/>
        </p:nvSpPr>
        <p:spPr>
          <a:xfrm>
            <a:off x="900000" y="510228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25"/>
          <p:cNvSpPr/>
          <p:nvPr/>
        </p:nvSpPr>
        <p:spPr>
          <a:xfrm>
            <a:off x="1883520" y="1790640"/>
            <a:ext cx="12096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Vincrist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examethas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sparagina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26"/>
          <p:cNvSpPr/>
          <p:nvPr/>
        </p:nvSpPr>
        <p:spPr>
          <a:xfrm>
            <a:off x="4073040" y="1916280"/>
            <a:ext cx="1342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6-Mercaptopur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examethas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8"/>
          <p:cNvSpPr/>
          <p:nvPr/>
        </p:nvSpPr>
        <p:spPr>
          <a:xfrm>
            <a:off x="6377400" y="1916280"/>
            <a:ext cx="1342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6-Mercaptopur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examethas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29"/>
          <p:cNvSpPr/>
          <p:nvPr/>
        </p:nvSpPr>
        <p:spPr>
          <a:xfrm>
            <a:off x="1941840" y="249228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Weeks 1-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30"/>
          <p:cNvSpPr/>
          <p:nvPr/>
        </p:nvSpPr>
        <p:spPr>
          <a:xfrm>
            <a:off x="4125960" y="2492280"/>
            <a:ext cx="108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Weeks 6-38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1"/>
          <p:cNvSpPr/>
          <p:nvPr/>
        </p:nvSpPr>
        <p:spPr>
          <a:xfrm>
            <a:off x="6392880" y="2492280"/>
            <a:ext cx="1627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Weeks 39-112 gir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           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39-164 boys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Rectangle 33"/>
          <p:cNvSpPr/>
          <p:nvPr/>
        </p:nvSpPr>
        <p:spPr>
          <a:xfrm>
            <a:off x="1619280" y="3265560"/>
            <a:ext cx="6265800" cy="73980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Straight Connector 34"/>
          <p:cNvSpPr/>
          <p:nvPr/>
        </p:nvSpPr>
        <p:spPr>
          <a:xfrm>
            <a:off x="3276720" y="3265560"/>
            <a:ext cx="0" cy="739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traight Connector 35"/>
          <p:cNvSpPr/>
          <p:nvPr/>
        </p:nvSpPr>
        <p:spPr>
          <a:xfrm>
            <a:off x="6300720" y="3265560"/>
            <a:ext cx="0" cy="739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36"/>
          <p:cNvSpPr/>
          <p:nvPr/>
        </p:nvSpPr>
        <p:spPr>
          <a:xfrm>
            <a:off x="1883520" y="3211560"/>
            <a:ext cx="12096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Vincrist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examethas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sparagina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aunorubic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7"/>
          <p:cNvSpPr/>
          <p:nvPr/>
        </p:nvSpPr>
        <p:spPr>
          <a:xfrm>
            <a:off x="4073040" y="3338640"/>
            <a:ext cx="1342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6-Mercaptopur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examethas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38"/>
          <p:cNvSpPr/>
          <p:nvPr/>
        </p:nvSpPr>
        <p:spPr>
          <a:xfrm>
            <a:off x="6377400" y="3338640"/>
            <a:ext cx="1342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6-Mercaptopur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examethas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9"/>
          <p:cNvSpPr/>
          <p:nvPr/>
        </p:nvSpPr>
        <p:spPr>
          <a:xfrm>
            <a:off x="1941840" y="405756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Weeks 1-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40"/>
          <p:cNvSpPr/>
          <p:nvPr/>
        </p:nvSpPr>
        <p:spPr>
          <a:xfrm>
            <a:off x="4125960" y="4057560"/>
            <a:ext cx="108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Weeks 6-40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41"/>
          <p:cNvSpPr/>
          <p:nvPr/>
        </p:nvSpPr>
        <p:spPr>
          <a:xfrm>
            <a:off x="6373800" y="4057560"/>
            <a:ext cx="1627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Weeks 41-114 gir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           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41-166 boys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Rectangle 45"/>
          <p:cNvSpPr/>
          <p:nvPr/>
        </p:nvSpPr>
        <p:spPr>
          <a:xfrm>
            <a:off x="1619280" y="4994280"/>
            <a:ext cx="6265800" cy="738360"/>
          </a:xfrm>
          <a:prstGeom prst="rect">
            <a:avLst/>
          </a:prstGeom>
          <a:solidFill>
            <a:srgbClr val="ffffff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traight Connector 46"/>
          <p:cNvSpPr/>
          <p:nvPr/>
        </p:nvSpPr>
        <p:spPr>
          <a:xfrm>
            <a:off x="3276720" y="4994280"/>
            <a:ext cx="0" cy="738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traight Connector 47"/>
          <p:cNvSpPr/>
          <p:nvPr/>
        </p:nvSpPr>
        <p:spPr>
          <a:xfrm>
            <a:off x="6300720" y="4994280"/>
            <a:ext cx="0" cy="7383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8"/>
          <p:cNvSpPr/>
          <p:nvPr/>
        </p:nvSpPr>
        <p:spPr>
          <a:xfrm>
            <a:off x="1883520" y="4940280"/>
            <a:ext cx="12096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Vincrist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examethas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Asparagina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aunorubici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49"/>
          <p:cNvSpPr/>
          <p:nvPr/>
        </p:nvSpPr>
        <p:spPr>
          <a:xfrm>
            <a:off x="4073040" y="5065560"/>
            <a:ext cx="13420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6-Mercaptopur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PEG asparaginas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Methotrexa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50"/>
          <p:cNvSpPr/>
          <p:nvPr/>
        </p:nvSpPr>
        <p:spPr>
          <a:xfrm>
            <a:off x="6377400" y="5065560"/>
            <a:ext cx="1342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6-Mercaptopuri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Dexamethason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51"/>
          <p:cNvSpPr/>
          <p:nvPr/>
        </p:nvSpPr>
        <p:spPr>
          <a:xfrm>
            <a:off x="1941840" y="5786280"/>
            <a:ext cx="95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Weeks 1-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52"/>
          <p:cNvSpPr/>
          <p:nvPr/>
        </p:nvSpPr>
        <p:spPr>
          <a:xfrm>
            <a:off x="4125960" y="5786280"/>
            <a:ext cx="1082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Weeks 6-46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53"/>
          <p:cNvSpPr/>
          <p:nvPr/>
        </p:nvSpPr>
        <p:spPr>
          <a:xfrm>
            <a:off x="6373800" y="5786280"/>
            <a:ext cx="1627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Weeks 47-118 girl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           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47-170 boys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Rectangle 2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Rectangle 5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Rectangle 7"/>
          <p:cNvSpPr/>
          <p:nvPr/>
        </p:nvSpPr>
        <p:spPr>
          <a:xfrm>
            <a:off x="0" y="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8" name="Group 7"/>
          <p:cNvGrpSpPr/>
          <p:nvPr/>
        </p:nvGrpSpPr>
        <p:grpSpPr>
          <a:xfrm>
            <a:off x="1677960" y="1477800"/>
            <a:ext cx="5630760" cy="3967200"/>
            <a:chOff x="1677960" y="1477800"/>
            <a:chExt cx="5630760" cy="3967200"/>
          </a:xfrm>
        </p:grpSpPr>
        <p:sp>
          <p:nvSpPr>
            <p:cNvPr id="89" name="TextBox 2"/>
            <p:cNvSpPr/>
            <p:nvPr/>
          </p:nvSpPr>
          <p:spPr>
            <a:xfrm>
              <a:off x="5580360" y="3717000"/>
              <a:ext cx="11520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</a:t>
              </a:r>
              <a:r>
                <a:rPr b="1" lang="en-GB" sz="12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2 </a:t>
              </a:r>
              <a:r>
                <a:rPr b="1" lang="en-GB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= 0.9218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aphicFrame>
          <p:nvGraphicFramePr>
            <p:cNvPr id="90" name="Object 12"/>
            <p:cNvGraphicFramePr/>
            <p:nvPr/>
          </p:nvGraphicFramePr>
          <p:xfrm>
            <a:off x="1677960" y="1477800"/>
            <a:ext cx="5630760" cy="396720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91" name="Object 12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677960" y="1477800"/>
                      <a:ext cx="5630760" cy="3967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92" name="TextBox 6"/>
          <p:cNvSpPr/>
          <p:nvPr/>
        </p:nvSpPr>
        <p:spPr>
          <a:xfrm>
            <a:off x="395280" y="765000"/>
            <a:ext cx="81374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ry Figure 2. Comparison of mutant levels for individual </a:t>
            </a:r>
            <a:r>
              <a:rPr b="0" i="1" lang="en-US" sz="1800" spc="-1" strike="noStrike">
                <a:solidFill>
                  <a:srgbClr val="000000"/>
                </a:solidFill>
                <a:latin typeface="Calibri"/>
              </a:rPr>
              <a:t>PTEN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 exon 7 mutants quantified in genomic DNA and whole-genome amplified (WGA) DNA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Rectangle 10"/>
          <p:cNvSpPr/>
          <p:nvPr/>
        </p:nvSpPr>
        <p:spPr>
          <a:xfrm>
            <a:off x="3132000" y="5013360"/>
            <a:ext cx="2952720" cy="4316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TextBox 11"/>
          <p:cNvSpPr/>
          <p:nvPr/>
        </p:nvSpPr>
        <p:spPr>
          <a:xfrm>
            <a:off x="2933640" y="5084640"/>
            <a:ext cx="3260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utant level in genomic DNA (%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Rectangle 13"/>
          <p:cNvSpPr/>
          <p:nvPr/>
        </p:nvSpPr>
        <p:spPr>
          <a:xfrm>
            <a:off x="1692360" y="1989000"/>
            <a:ext cx="431640" cy="2592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12"/>
          <p:cNvSpPr/>
          <p:nvPr/>
        </p:nvSpPr>
        <p:spPr>
          <a:xfrm rot="16200000">
            <a:off x="329760" y="3005640"/>
            <a:ext cx="2946960" cy="36828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Mutant level in WGA DNA (%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TextBox 60"/>
          <p:cNvSpPr/>
          <p:nvPr/>
        </p:nvSpPr>
        <p:spPr>
          <a:xfrm>
            <a:off x="611280" y="115920"/>
            <a:ext cx="7056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Supplementary Figure 3. B-allele Frequency (BAF) and LogR ratio plots for wild-type (WT)</a:t>
            </a:r>
            <a:r>
              <a:rPr b="0" i="1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, 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heterozygous and homozygous </a:t>
            </a:r>
            <a:r>
              <a:rPr b="0" i="1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PTEN 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deletion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8" name="Group 9"/>
          <p:cNvGrpSpPr/>
          <p:nvPr/>
        </p:nvGrpSpPr>
        <p:grpSpPr>
          <a:xfrm>
            <a:off x="1692360" y="787320"/>
            <a:ext cx="6283080" cy="6026400"/>
            <a:chOff x="1692360" y="787320"/>
            <a:chExt cx="6283080" cy="6026400"/>
          </a:xfrm>
        </p:grpSpPr>
        <p:grpSp>
          <p:nvGrpSpPr>
            <p:cNvPr id="99" name="Group 21"/>
            <p:cNvGrpSpPr/>
            <p:nvPr/>
          </p:nvGrpSpPr>
          <p:grpSpPr>
            <a:xfrm>
              <a:off x="1692360" y="787320"/>
              <a:ext cx="3752640" cy="6026400"/>
              <a:chOff x="1692360" y="787320"/>
              <a:chExt cx="3752640" cy="6026400"/>
            </a:xfrm>
          </p:grpSpPr>
          <p:grpSp>
            <p:nvGrpSpPr>
              <p:cNvPr id="100" name="Group 22"/>
              <p:cNvGrpSpPr/>
              <p:nvPr/>
            </p:nvGrpSpPr>
            <p:grpSpPr>
              <a:xfrm>
                <a:off x="1692360" y="902160"/>
                <a:ext cx="3752640" cy="5911560"/>
                <a:chOff x="1692360" y="902160"/>
                <a:chExt cx="3752640" cy="5911560"/>
              </a:xfrm>
            </p:grpSpPr>
            <p:grpSp>
              <p:nvGrpSpPr>
                <p:cNvPr id="101" name="Group 25"/>
                <p:cNvGrpSpPr/>
                <p:nvPr/>
              </p:nvGrpSpPr>
              <p:grpSpPr>
                <a:xfrm>
                  <a:off x="1867680" y="902160"/>
                  <a:ext cx="3036240" cy="4787280"/>
                  <a:chOff x="1867680" y="902160"/>
                  <a:chExt cx="3036240" cy="4787280"/>
                </a:xfrm>
              </p:grpSpPr>
              <p:grpSp>
                <p:nvGrpSpPr>
                  <p:cNvPr id="102" name="Group 38"/>
                  <p:cNvGrpSpPr/>
                  <p:nvPr/>
                </p:nvGrpSpPr>
                <p:grpSpPr>
                  <a:xfrm>
                    <a:off x="1867680" y="902160"/>
                    <a:ext cx="3036240" cy="1671840"/>
                    <a:chOff x="1867680" y="902160"/>
                    <a:chExt cx="3036240" cy="1671840"/>
                  </a:xfrm>
                </p:grpSpPr>
                <p:pic>
                  <p:nvPicPr>
                    <p:cNvPr id="103" name="Picture 2" descr=""/>
                    <p:cNvPicPr/>
                    <p:nvPr/>
                  </p:nvPicPr>
                  <p:blipFill>
                    <a:blip r:embed="rId1"/>
                    <a:stretch/>
                  </p:blipFill>
                  <p:spPr>
                    <a:xfrm>
                      <a:off x="2301840" y="1065960"/>
                      <a:ext cx="2602080" cy="1446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04" name="Picture 6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867680" y="902160"/>
                      <a:ext cx="478800" cy="8766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05" name="Picture 9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1912680" y="1778760"/>
                      <a:ext cx="433440" cy="795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grpSp>
                <p:nvGrpSpPr>
                  <p:cNvPr id="106" name="Group 39"/>
                  <p:cNvGrpSpPr/>
                  <p:nvPr/>
                </p:nvGrpSpPr>
                <p:grpSpPr>
                  <a:xfrm>
                    <a:off x="1899720" y="4033080"/>
                    <a:ext cx="2979720" cy="1656360"/>
                    <a:chOff x="1899720" y="4033080"/>
                    <a:chExt cx="2979720" cy="1656360"/>
                  </a:xfrm>
                </p:grpSpPr>
                <p:pic>
                  <p:nvPicPr>
                    <p:cNvPr id="107" name="Picture 5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2365560" y="4179600"/>
                      <a:ext cx="2513880" cy="14720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08" name="Picture 7" descr=""/>
                    <p:cNvPicPr/>
                    <p:nvPr/>
                  </p:nvPicPr>
                  <p:blipFill>
                    <a:blip r:embed="rId5"/>
                    <a:stretch/>
                  </p:blipFill>
                  <p:spPr>
                    <a:xfrm>
                      <a:off x="1899720" y="4033080"/>
                      <a:ext cx="465840" cy="852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09" name="Picture 10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1961640" y="4915800"/>
                      <a:ext cx="421920" cy="773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grpSp>
                <p:nvGrpSpPr>
                  <p:cNvPr id="110" name="Group 46"/>
                  <p:cNvGrpSpPr/>
                  <p:nvPr/>
                </p:nvGrpSpPr>
                <p:grpSpPr>
                  <a:xfrm>
                    <a:off x="1895040" y="2507760"/>
                    <a:ext cx="2993400" cy="1659600"/>
                    <a:chOff x="1895040" y="2507760"/>
                    <a:chExt cx="2993400" cy="1659600"/>
                  </a:xfrm>
                </p:grpSpPr>
                <p:pic>
                  <p:nvPicPr>
                    <p:cNvPr id="111" name="Picture 12" descr=""/>
                    <p:cNvPicPr/>
                    <p:nvPr/>
                  </p:nvPicPr>
                  <p:blipFill>
                    <a:blip r:embed="rId7"/>
                    <a:stretch/>
                  </p:blipFill>
                  <p:spPr>
                    <a:xfrm>
                      <a:off x="2294280" y="2643840"/>
                      <a:ext cx="2594160" cy="1468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12" name="Picture 7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1895040" y="2507760"/>
                      <a:ext cx="465840" cy="852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13" name="Picture 10" descr=""/>
                    <p:cNvPicPr/>
                    <p:nvPr/>
                  </p:nvPicPr>
                  <p:blipFill>
                    <a:blip r:embed="rId9"/>
                    <a:stretch/>
                  </p:blipFill>
                  <p:spPr>
                    <a:xfrm>
                      <a:off x="1948320" y="3393720"/>
                      <a:ext cx="421920" cy="773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</p:grpSp>
            <p:sp>
              <p:nvSpPr>
                <p:cNvPr id="114" name="Straight Connector 26"/>
                <p:cNvSpPr/>
                <p:nvPr/>
              </p:nvSpPr>
              <p:spPr>
                <a:xfrm>
                  <a:off x="4246200" y="5915880"/>
                  <a:ext cx="211320" cy="55008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5" name="Straight Connector 27"/>
                <p:cNvSpPr/>
                <p:nvPr/>
              </p:nvSpPr>
              <p:spPr>
                <a:xfrm flipV="1">
                  <a:off x="4457520" y="5915520"/>
                  <a:ext cx="123120" cy="4071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pic>
              <p:nvPicPr>
                <p:cNvPr id="116" name="Picture 3" descr="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1692360" y="6307560"/>
                  <a:ext cx="3752640" cy="28548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117" name="TextBox 29"/>
                <p:cNvSpPr/>
                <p:nvPr/>
              </p:nvSpPr>
              <p:spPr>
                <a:xfrm>
                  <a:off x="4191480" y="6567480"/>
                  <a:ext cx="7200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10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0q23</a:t>
                  </a:r>
                  <a:endParaRPr b="0" lang="en-US" sz="10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8" name="TextBox 30"/>
                <p:cNvSpPr/>
                <p:nvPr/>
              </p:nvSpPr>
              <p:spPr>
                <a:xfrm>
                  <a:off x="3967560" y="5668920"/>
                  <a:ext cx="6771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9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89.6Mb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19" name="TextBox 31"/>
                <p:cNvSpPr/>
                <p:nvPr/>
              </p:nvSpPr>
              <p:spPr>
                <a:xfrm>
                  <a:off x="4428720" y="5668920"/>
                  <a:ext cx="70992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GB" sz="9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89.7Mb</a:t>
                  </a:r>
                  <a:endParaRPr b="0" lang="en-US" sz="9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20" name="Straight Connector 37"/>
                <p:cNvSpPr/>
                <p:nvPr/>
              </p:nvSpPr>
              <p:spPr>
                <a:xfrm>
                  <a:off x="4305960" y="5668920"/>
                  <a:ext cx="0" cy="0"/>
                </a:xfrm>
                <a:prstGeom prst="line">
                  <a:avLst/>
                </a:prstGeom>
                <a:ln w="9360">
                  <a:solidFill>
                    <a:srgbClr val="4a7ebb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21" name="TextBox 23"/>
              <p:cNvSpPr/>
              <p:nvPr/>
            </p:nvSpPr>
            <p:spPr>
              <a:xfrm>
                <a:off x="4068360" y="787320"/>
                <a:ext cx="974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TEN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22" name="TextBox 4"/>
            <p:cNvSpPr/>
            <p:nvPr/>
          </p:nvSpPr>
          <p:spPr>
            <a:xfrm>
              <a:off x="5373360" y="1577880"/>
              <a:ext cx="816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A) WT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TextBox 61"/>
            <p:cNvSpPr/>
            <p:nvPr/>
          </p:nvSpPr>
          <p:spPr>
            <a:xfrm>
              <a:off x="5380560" y="3164760"/>
              <a:ext cx="2594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B) Heterozygous deletion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TextBox 63"/>
            <p:cNvSpPr/>
            <p:nvPr/>
          </p:nvSpPr>
          <p:spPr>
            <a:xfrm>
              <a:off x="5380560" y="4692240"/>
              <a:ext cx="2511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(C) Homozygous deletion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Right Brace 64"/>
            <p:cNvSpPr/>
            <p:nvPr/>
          </p:nvSpPr>
          <p:spPr>
            <a:xfrm>
              <a:off x="5076720" y="1333800"/>
              <a:ext cx="155160" cy="914400"/>
            </a:xfrm>
            <a:custGeom>
              <a:avLst/>
              <a:gdLst>
                <a:gd name="textAreaLeft" fmla="*/ 0 w 155160"/>
                <a:gd name="textAreaRight" fmla="*/ 56160 w 155160"/>
                <a:gd name="textAreaTop" fmla="*/ 3960 h 914400"/>
                <a:gd name="textAreaBottom" fmla="*/ 910440 h 914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3"/>
                    <a:pt x="10800" y="306"/>
                  </a:cubicBezTo>
                  <a:lnTo>
                    <a:pt x="10800" y="10494"/>
                  </a:lnTo>
                  <a:cubicBezTo>
                    <a:pt x="10800" y="10647"/>
                    <a:pt x="16200" y="10800"/>
                    <a:pt x="21600" y="10800"/>
                  </a:cubicBezTo>
                  <a:cubicBezTo>
                    <a:pt x="16200" y="10800"/>
                    <a:pt x="10800" y="10953"/>
                    <a:pt x="10800" y="11106"/>
                  </a:cubicBezTo>
                  <a:lnTo>
                    <a:pt x="10800" y="21294"/>
                  </a:lnTo>
                  <a:cubicBezTo>
                    <a:pt x="10800" y="21447"/>
                    <a:pt x="5400" y="21600"/>
                    <a:pt x="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`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ight Brace 65"/>
            <p:cNvSpPr/>
            <p:nvPr/>
          </p:nvSpPr>
          <p:spPr>
            <a:xfrm>
              <a:off x="5088240" y="2929680"/>
              <a:ext cx="155160" cy="914400"/>
            </a:xfrm>
            <a:custGeom>
              <a:avLst/>
              <a:gdLst>
                <a:gd name="textAreaLeft" fmla="*/ 0 w 155160"/>
                <a:gd name="textAreaRight" fmla="*/ 56160 w 155160"/>
                <a:gd name="textAreaTop" fmla="*/ 3960 h 914400"/>
                <a:gd name="textAreaBottom" fmla="*/ 910440 h 914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3"/>
                    <a:pt x="10800" y="306"/>
                  </a:cubicBezTo>
                  <a:lnTo>
                    <a:pt x="10800" y="10494"/>
                  </a:lnTo>
                  <a:cubicBezTo>
                    <a:pt x="10800" y="10647"/>
                    <a:pt x="16200" y="10800"/>
                    <a:pt x="21600" y="10800"/>
                  </a:cubicBezTo>
                  <a:cubicBezTo>
                    <a:pt x="16200" y="10800"/>
                    <a:pt x="10800" y="10953"/>
                    <a:pt x="10800" y="11106"/>
                  </a:cubicBezTo>
                  <a:lnTo>
                    <a:pt x="10800" y="21294"/>
                  </a:lnTo>
                  <a:cubicBezTo>
                    <a:pt x="10800" y="21447"/>
                    <a:pt x="5400" y="21600"/>
                    <a:pt x="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Right Brace 66"/>
            <p:cNvSpPr/>
            <p:nvPr/>
          </p:nvSpPr>
          <p:spPr>
            <a:xfrm>
              <a:off x="5088240" y="4458960"/>
              <a:ext cx="155160" cy="914400"/>
            </a:xfrm>
            <a:custGeom>
              <a:avLst/>
              <a:gdLst>
                <a:gd name="textAreaLeft" fmla="*/ 0 w 155160"/>
                <a:gd name="textAreaRight" fmla="*/ 56160 w 155160"/>
                <a:gd name="textAreaTop" fmla="*/ 3960 h 914400"/>
                <a:gd name="textAreaBottom" fmla="*/ 910440 h 91440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153"/>
                    <a:pt x="10800" y="306"/>
                  </a:cubicBezTo>
                  <a:lnTo>
                    <a:pt x="10800" y="10494"/>
                  </a:lnTo>
                  <a:cubicBezTo>
                    <a:pt x="10800" y="10647"/>
                    <a:pt x="16200" y="10800"/>
                    <a:pt x="21600" y="10800"/>
                  </a:cubicBezTo>
                  <a:cubicBezTo>
                    <a:pt x="16200" y="10800"/>
                    <a:pt x="10800" y="10953"/>
                    <a:pt x="10800" y="11106"/>
                  </a:cubicBezTo>
                  <a:lnTo>
                    <a:pt x="10800" y="21294"/>
                  </a:lnTo>
                  <a:cubicBezTo>
                    <a:pt x="10800" y="21447"/>
                    <a:pt x="5400" y="21600"/>
                    <a:pt x="0" y="21600"/>
                  </a:cubicBezTo>
                </a:path>
              </a:pathLst>
            </a:cu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TextBox 6"/>
          <p:cNvSpPr/>
          <p:nvPr/>
        </p:nvSpPr>
        <p:spPr>
          <a:xfrm>
            <a:off x="611280" y="365040"/>
            <a:ext cx="777708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Supplementary Figure 4. Survival stratified according to </a:t>
            </a:r>
            <a:r>
              <a:rPr b="0" i="1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RAS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 genotype.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(A) Relapse-free survival, (B) Overall survival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29" name="Picture 8" descr=""/>
          <p:cNvPicPr/>
          <p:nvPr/>
        </p:nvPicPr>
        <p:blipFill>
          <a:blip r:embed="rId1"/>
          <a:stretch/>
        </p:blipFill>
        <p:spPr>
          <a:xfrm>
            <a:off x="611280" y="1700280"/>
            <a:ext cx="3816360" cy="2663640"/>
          </a:xfrm>
          <a:prstGeom prst="rect">
            <a:avLst/>
          </a:prstGeom>
          <a:ln w="0">
            <a:noFill/>
          </a:ln>
        </p:spPr>
      </p:pic>
      <p:pic>
        <p:nvPicPr>
          <p:cNvPr id="130" name="Picture 9" descr=""/>
          <p:cNvPicPr/>
          <p:nvPr/>
        </p:nvPicPr>
        <p:blipFill>
          <a:blip r:embed="rId2"/>
          <a:stretch/>
        </p:blipFill>
        <p:spPr>
          <a:xfrm>
            <a:off x="4788000" y="1727280"/>
            <a:ext cx="3816360" cy="2663640"/>
          </a:xfrm>
          <a:prstGeom prst="rect">
            <a:avLst/>
          </a:prstGeom>
          <a:ln w="0">
            <a:noFill/>
          </a:ln>
        </p:spPr>
      </p:pic>
      <p:sp>
        <p:nvSpPr>
          <p:cNvPr id="131" name="TextBox 14"/>
          <p:cNvSpPr/>
          <p:nvPr/>
        </p:nvSpPr>
        <p:spPr>
          <a:xfrm>
            <a:off x="4884840" y="134136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15"/>
          <p:cNvSpPr/>
          <p:nvPr/>
        </p:nvSpPr>
        <p:spPr>
          <a:xfrm>
            <a:off x="4341960" y="181764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  <a:ea typeface="Times New Roman"/>
              </a:rPr>
              <a:t>92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16"/>
          <p:cNvSpPr/>
          <p:nvPr/>
        </p:nvSpPr>
        <p:spPr>
          <a:xfrm>
            <a:off x="4340160" y="198108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  <a:ea typeface="Times New Roman"/>
              </a:rPr>
              <a:t>86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TextBox 18"/>
          <p:cNvSpPr/>
          <p:nvPr/>
        </p:nvSpPr>
        <p:spPr>
          <a:xfrm>
            <a:off x="684360" y="134136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Rectangle 19"/>
          <p:cNvSpPr/>
          <p:nvPr/>
        </p:nvSpPr>
        <p:spPr>
          <a:xfrm>
            <a:off x="3924360" y="1844640"/>
            <a:ext cx="287280" cy="144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Rectangle 20"/>
          <p:cNvSpPr/>
          <p:nvPr/>
        </p:nvSpPr>
        <p:spPr>
          <a:xfrm>
            <a:off x="3914640" y="2133720"/>
            <a:ext cx="287640" cy="142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TextBox 21"/>
          <p:cNvSpPr/>
          <p:nvPr/>
        </p:nvSpPr>
        <p:spPr>
          <a:xfrm>
            <a:off x="8497800" y="1800360"/>
            <a:ext cx="46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  <a:ea typeface="Times New Roman"/>
              </a:rPr>
              <a:t>92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TextBox 22"/>
          <p:cNvSpPr/>
          <p:nvPr/>
        </p:nvSpPr>
        <p:spPr>
          <a:xfrm>
            <a:off x="8496360" y="1963800"/>
            <a:ext cx="466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Calibri"/>
                <a:ea typeface="Times New Roman"/>
              </a:rPr>
              <a:t>89%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Rectangle 23"/>
          <p:cNvSpPr/>
          <p:nvPr/>
        </p:nvSpPr>
        <p:spPr>
          <a:xfrm>
            <a:off x="8101080" y="1859040"/>
            <a:ext cx="287280" cy="142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Rectangle 24"/>
          <p:cNvSpPr/>
          <p:nvPr/>
        </p:nvSpPr>
        <p:spPr>
          <a:xfrm>
            <a:off x="8089920" y="2133720"/>
            <a:ext cx="289080" cy="142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TextBox 6"/>
          <p:cNvSpPr/>
          <p:nvPr/>
        </p:nvSpPr>
        <p:spPr>
          <a:xfrm>
            <a:off x="395280" y="260280"/>
            <a:ext cx="8424720" cy="1129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Supplementary Figure 5. Survival stratified according to the oncogenetic </a:t>
            </a:r>
            <a:r>
              <a:rPr b="0" i="1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NOTCH1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/</a:t>
            </a:r>
            <a:r>
              <a:rPr b="0" i="1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FBXW7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/</a:t>
            </a:r>
            <a:r>
              <a:rPr b="0" i="1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RAS/PTEN 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classification system proposed for adults. 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(A) Relapse-free survival, (B) Overall survival. The low-risk group have a </a:t>
            </a:r>
            <a:r>
              <a:rPr b="0" i="1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NOTCH1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 and/or </a:t>
            </a:r>
            <a:r>
              <a:rPr b="0" i="1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FBXW7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 mutation in the absence of a </a:t>
            </a:r>
            <a:r>
              <a:rPr b="0" i="1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RAS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 or </a:t>
            </a:r>
            <a:r>
              <a:rPr b="0" i="1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PTEN</a:t>
            </a:r>
            <a:r>
              <a:rPr b="0" lang="en-GB" sz="1600" spc="-1" strike="noStrike">
                <a:solidFill>
                  <a:srgbClr val="000000"/>
                </a:solidFill>
                <a:latin typeface="Calibri"/>
                <a:ea typeface="Times New Roman"/>
              </a:rPr>
              <a:t> mutation. All other patients are in the high-risk group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TextBox 14"/>
          <p:cNvSpPr/>
          <p:nvPr/>
        </p:nvSpPr>
        <p:spPr>
          <a:xfrm>
            <a:off x="4884840" y="158580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TextBox 18"/>
          <p:cNvSpPr/>
          <p:nvPr/>
        </p:nvSpPr>
        <p:spPr>
          <a:xfrm>
            <a:off x="417600" y="1585800"/>
            <a:ext cx="43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Rectangle 19"/>
          <p:cNvSpPr/>
          <p:nvPr/>
        </p:nvSpPr>
        <p:spPr>
          <a:xfrm>
            <a:off x="3924360" y="1844640"/>
            <a:ext cx="287280" cy="14436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Rectangle 20"/>
          <p:cNvSpPr/>
          <p:nvPr/>
        </p:nvSpPr>
        <p:spPr>
          <a:xfrm>
            <a:off x="3914640" y="2133720"/>
            <a:ext cx="287640" cy="142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Rectangle 24"/>
          <p:cNvSpPr/>
          <p:nvPr/>
        </p:nvSpPr>
        <p:spPr>
          <a:xfrm>
            <a:off x="8089920" y="2133720"/>
            <a:ext cx="289080" cy="14292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Rectangle 28"/>
          <p:cNvSpPr/>
          <p:nvPr/>
        </p:nvSpPr>
        <p:spPr>
          <a:xfrm>
            <a:off x="7236000" y="1916280"/>
            <a:ext cx="360360" cy="217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48" name="Group 4"/>
          <p:cNvGrpSpPr/>
          <p:nvPr/>
        </p:nvGrpSpPr>
        <p:grpSpPr>
          <a:xfrm>
            <a:off x="4284720" y="2060640"/>
            <a:ext cx="4824360" cy="3324240"/>
            <a:chOff x="4284720" y="2060640"/>
            <a:chExt cx="4824360" cy="3324240"/>
          </a:xfrm>
        </p:grpSpPr>
        <p:pic>
          <p:nvPicPr>
            <p:cNvPr id="149" name="Picture 26" descr="OS_High_low_risk2.tif"/>
            <p:cNvPicPr/>
            <p:nvPr/>
          </p:nvPicPr>
          <p:blipFill>
            <a:blip r:embed="rId1"/>
            <a:stretch/>
          </p:blipFill>
          <p:spPr>
            <a:xfrm>
              <a:off x="4284720" y="2060640"/>
              <a:ext cx="4572000" cy="3324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0" name="Rectangle 23"/>
            <p:cNvSpPr/>
            <p:nvPr/>
          </p:nvSpPr>
          <p:spPr>
            <a:xfrm>
              <a:off x="8245080" y="2216160"/>
              <a:ext cx="360000" cy="144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Rectangle 29"/>
            <p:cNvSpPr/>
            <p:nvPr/>
          </p:nvSpPr>
          <p:spPr>
            <a:xfrm>
              <a:off x="8245080" y="2628720"/>
              <a:ext cx="360000" cy="144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TextBox 21"/>
            <p:cNvSpPr/>
            <p:nvPr/>
          </p:nvSpPr>
          <p:spPr>
            <a:xfrm>
              <a:off x="8643240" y="2216160"/>
              <a:ext cx="46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94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TextBox 22"/>
            <p:cNvSpPr/>
            <p:nvPr/>
          </p:nvSpPr>
          <p:spPr>
            <a:xfrm>
              <a:off x="8643240" y="2456640"/>
              <a:ext cx="46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84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54" name="Group 11"/>
          <p:cNvGrpSpPr/>
          <p:nvPr/>
        </p:nvGrpSpPr>
        <p:grpSpPr>
          <a:xfrm>
            <a:off x="-219240" y="2035080"/>
            <a:ext cx="4897440" cy="3378240"/>
            <a:chOff x="-219240" y="2035080"/>
            <a:chExt cx="4897440" cy="3378240"/>
          </a:xfrm>
        </p:grpSpPr>
        <p:pic>
          <p:nvPicPr>
            <p:cNvPr id="155" name="Picture 25" descr="RFS_High_low_risk2.tif"/>
            <p:cNvPicPr/>
            <p:nvPr/>
          </p:nvPicPr>
          <p:blipFill>
            <a:blip r:embed="rId2"/>
            <a:stretch/>
          </p:blipFill>
          <p:spPr>
            <a:xfrm>
              <a:off x="-219240" y="2035080"/>
              <a:ext cx="4647600" cy="3378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6" name="Rectangle 1"/>
            <p:cNvSpPr/>
            <p:nvPr/>
          </p:nvSpPr>
          <p:spPr>
            <a:xfrm>
              <a:off x="3780360" y="2282040"/>
              <a:ext cx="36000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Rectangle 27"/>
            <p:cNvSpPr/>
            <p:nvPr/>
          </p:nvSpPr>
          <p:spPr>
            <a:xfrm>
              <a:off x="3780360" y="2565360"/>
              <a:ext cx="360000" cy="216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TextBox 15"/>
            <p:cNvSpPr/>
            <p:nvPr/>
          </p:nvSpPr>
          <p:spPr>
            <a:xfrm>
              <a:off x="4212360" y="2372760"/>
              <a:ext cx="465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Calibri"/>
                  <a:ea typeface="Times New Roman"/>
                </a:rPr>
                <a:t>87%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6T14:04:38Z</dcterms:created>
  <dc:creator>Compaq</dc:creator>
  <dc:description/>
  <dc:language>en-US</dc:language>
  <cp:lastModifiedBy>ravikumar.s</cp:lastModifiedBy>
  <cp:lastPrinted>2015-03-16T16:44:30Z</cp:lastPrinted>
  <dcterms:modified xsi:type="dcterms:W3CDTF">2015-08-13T12:54:39Z</dcterms:modified>
  <cp:revision>27</cp:revision>
  <dc:subject/>
  <dc:title>PowerPoint Presentation</dc:title>
</cp:coreProperties>
</file>